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4"/>
  </p:sldMasterIdLst>
  <p:notesMasterIdLst>
    <p:notesMasterId r:id="rId9"/>
  </p:notesMasterIdLst>
  <p:sldIdLst>
    <p:sldId id="1228" r:id="rId5"/>
    <p:sldId id="1230" r:id="rId6"/>
    <p:sldId id="1232" r:id="rId7"/>
    <p:sldId id="1233" r:id="rId8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8025" autoAdjust="0"/>
    <p:restoredTop sz="94660"/>
  </p:normalViewPr>
  <p:slideViewPr>
    <p:cSldViewPr snapToGrid="0">
      <p:cViewPr varScale="1">
        <p:scale>
          <a:sx n="119" d="100"/>
          <a:sy n="119" d="100"/>
        </p:scale>
        <p:origin x="96" y="34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4.xml"/><Relationship Id="rId13" Type="http://schemas.openxmlformats.org/officeDocument/2006/relationships/tableStyles" Target="tableStyles.xml"/><Relationship Id="rId3" Type="http://schemas.openxmlformats.org/officeDocument/2006/relationships/customXml" Target="../customXml/item3.xml"/><Relationship Id="rId7" Type="http://schemas.openxmlformats.org/officeDocument/2006/relationships/slide" Target="slides/slide3.xml"/><Relationship Id="rId12" Type="http://schemas.openxmlformats.org/officeDocument/2006/relationships/theme" Target="theme/theme1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slide" Target="slides/slide2.xml"/><Relationship Id="rId11" Type="http://schemas.openxmlformats.org/officeDocument/2006/relationships/viewProps" Target="viewProps.xml"/><Relationship Id="rId5" Type="http://schemas.openxmlformats.org/officeDocument/2006/relationships/slide" Target="slides/slide1.xml"/><Relationship Id="rId10" Type="http://schemas.openxmlformats.org/officeDocument/2006/relationships/presProps" Target="presProps.xml"/><Relationship Id="rId4" Type="http://schemas.openxmlformats.org/officeDocument/2006/relationships/slideMaster" Target="slideMasters/slideMaster1.xml"/><Relationship Id="rId9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DD20E1B-3E64-4E44-8E49-771258E87053}" type="datetimeFigureOut">
              <a:rPr lang="en-US" smtClean="0"/>
              <a:t>3/28/2021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DD803F5-E5D3-4D41-8AC7-7FC948925D8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2149903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CC9EE49-38D6-4E55-82F7-0167DA0C4FA1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1319DFFE-AD1F-40C0-AE24-AD5E52DA0F60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9494976-3F0B-4E8B-8208-0E05F5583B8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EEDC51-7057-4F86-864E-02967C951E54}" type="datetimeFigureOut">
              <a:rPr lang="en-US" smtClean="0"/>
              <a:t>3/28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026FF56-B30B-4E03-A0E4-3A44DDFDF5A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3A31D69-ADC9-448D-999F-3322C025565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8324B3-9943-4AFD-AD62-17255A12F2A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5736113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E3560A6-1B23-4BAD-85C3-20AF840C9DB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7F558710-DB8E-4B76-900E-595AB1C895A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8077492-9C61-4150-A5E4-A1ACC8BDDCC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EEDC51-7057-4F86-864E-02967C951E54}" type="datetimeFigureOut">
              <a:rPr lang="en-US" smtClean="0"/>
              <a:t>3/28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E20ADCE-6EC7-4A66-A5CE-1574F8B0901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BB5F701-6737-4975-9050-EF10DFE6872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8324B3-9943-4AFD-AD62-17255A12F2A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5280920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A6DC2CCA-2153-406F-B620-5165AEBCC6B8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03EA2FEB-2DD2-4DF4-B55A-69851717A4B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3964BF9-AAC9-44A1-B686-917DCEDF6AD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EEDC51-7057-4F86-864E-02967C951E54}" type="datetimeFigureOut">
              <a:rPr lang="en-US" smtClean="0"/>
              <a:t>3/28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9F5B741-C2B1-4C38-ABCA-0707FD7AE15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BA7CB9F-D05B-47D7-8862-CD2E787C4AF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8324B3-9943-4AFD-AD62-17255A12F2A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0962418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ABFED64-2978-4906-971A-0C30B024640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B3486F9-899E-4E61-BD97-00ECEA97BEEA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852D7A3-0FB1-4765-804A-66A8CD25CCA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EEDC51-7057-4F86-864E-02967C951E54}" type="datetimeFigureOut">
              <a:rPr lang="en-US" smtClean="0"/>
              <a:t>3/28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B7A84A8-C772-4AA9-AD01-E4AB5E27541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4134F50-803E-4A34-9CE4-DFCAF4917F3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8324B3-9943-4AFD-AD62-17255A12F2A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0077930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BC27402-B6F7-496F-9168-737333FB023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5218033-8254-4069-A7C3-367390B1A77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7108C8F-4BE8-412C-A5C5-EBF07434675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EEDC51-7057-4F86-864E-02967C951E54}" type="datetimeFigureOut">
              <a:rPr lang="en-US" smtClean="0"/>
              <a:t>3/28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921C04F-E6BA-469A-B8A0-A7F7F6641B9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F93E45A-275D-4789-9B8A-0F165DE520E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8324B3-9943-4AFD-AD62-17255A12F2A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9971244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45BD979-90E3-4D18-BF7F-584E3FE4F8E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F0B7C3F-E181-4C40-8551-57491701F9E8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2EC314BF-C22E-46FE-99B4-16FF3FD9B67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F87D311-995D-4A96-AB63-E246BBCCC17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EEDC51-7057-4F86-864E-02967C951E54}" type="datetimeFigureOut">
              <a:rPr lang="en-US" smtClean="0"/>
              <a:t>3/28/20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1968B2F-F9D9-4A88-9113-0113B4A6C0B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1834612-BC87-4D48-8EF7-F0E896E1ABF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8324B3-9943-4AFD-AD62-17255A12F2A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587684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F78746D-DB48-45D1-9E4A-BFF87B49060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20E256F-32F3-4CD7-8D03-BCB2B75A094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202CBC4C-EAF8-4999-8F86-357FE86F46C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3BC4B1A6-8ECE-4BA8-9F3D-207BF2A05500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1E3FEF7C-628D-4BFC-A986-E51785C46DDD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D0E1C663-F600-4659-8A62-31B9D22A92C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EEDC51-7057-4F86-864E-02967C951E54}" type="datetimeFigureOut">
              <a:rPr lang="en-US" smtClean="0"/>
              <a:t>3/28/2021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F91394FD-434B-49A0-B7B7-E5AA6D654B1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10F5F51C-A0EF-4A23-91F9-55D0687D5F9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8324B3-9943-4AFD-AD62-17255A12F2A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6784423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D1B70E8-54D0-46F9-B69A-CDAFD1DF9DB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72BE95E5-0977-4EFC-B4E9-74BF587A30F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EEDC51-7057-4F86-864E-02967C951E54}" type="datetimeFigureOut">
              <a:rPr lang="en-US" smtClean="0"/>
              <a:t>3/28/2021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35D426E2-1E29-4EEB-B2C2-122B010545E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7B9FAE89-106F-45F7-8FF8-437163202CD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8324B3-9943-4AFD-AD62-17255A12F2A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152007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C00ECE79-EC41-4291-93C3-122193AE11E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EEDC51-7057-4F86-864E-02967C951E54}" type="datetimeFigureOut">
              <a:rPr lang="en-US" smtClean="0"/>
              <a:t>3/28/2021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891EA767-D8CC-4F85-A306-4379B4E555F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A0FA106E-C4B7-45FC-B960-8FCD9053D9E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8324B3-9943-4AFD-AD62-17255A12F2A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3630816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86D90AD-5063-4E1A-9CD1-9C4D1529DC5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5E132BB-7071-45B8-9D4A-8F5AD9A2855B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A59F5E45-BB35-4CFA-A6C8-3879F4B44ED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16F475A2-95D4-45B0-8357-3AB34898EE0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EEDC51-7057-4F86-864E-02967C951E54}" type="datetimeFigureOut">
              <a:rPr lang="en-US" smtClean="0"/>
              <a:t>3/28/20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2DB3094-A30E-4D54-BCCD-1D870ABC17D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0854AE6-B70E-4D9B-9AF0-1D674B6CFF7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8324B3-9943-4AFD-AD62-17255A12F2A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6454663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1872D05-1D5F-4C20-A961-91D041AB316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24208714-59FB-404D-855E-91D7E4439245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230433D4-7F52-498A-954C-405ACAB40F9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9AE6348-C8B5-4AE2-9EB8-6B87D54429E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EEDC51-7057-4F86-864E-02967C951E54}" type="datetimeFigureOut">
              <a:rPr lang="en-US" smtClean="0"/>
              <a:t>3/28/20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1DE4293-4006-4FC5-87A0-63017753601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6E6827B-260C-48EA-9024-BD0F7D727ED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8324B3-9943-4AFD-AD62-17255A12F2A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4610334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568C8844-0AC5-4BD7-82C8-8EACC64535D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18825C4-D291-41F3-88AD-8D43FE4FF2E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73E45E1-238E-4E7E-8866-BF6B70B73D97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FEEDC51-7057-4F86-864E-02967C951E54}" type="datetimeFigureOut">
              <a:rPr lang="en-US" smtClean="0"/>
              <a:t>3/28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88B1C0D-B282-4F21-A9FE-AFBFCF95EA4C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F9A37CF-3812-472A-B598-2DB8F67CC6A7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98324B3-9943-4AFD-AD62-17255A12F2A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9598055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EMF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EM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76A89889-7BF7-444A-9663-47011429483E}"/>
              </a:ext>
            </a:extLst>
          </p:cNvPr>
          <p:cNvSpPr txBox="1"/>
          <p:nvPr/>
        </p:nvSpPr>
        <p:spPr>
          <a:xfrm>
            <a:off x="248653" y="1892969"/>
            <a:ext cx="11782925" cy="34163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dditional file 2: Distribution of log</a:t>
            </a:r>
            <a:r>
              <a:rPr lang="en-US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0</a:t>
            </a:r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LR) values for H1-true and H2-true tests of two, three, and four person mixtures by software and varying DNA treatments</a:t>
            </a:r>
            <a:r>
              <a:rPr lang="en-US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plots are distributions of log</a:t>
            </a:r>
            <a:r>
              <a:rPr lang="en-US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0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(LRs) as function of NOC, software, propositions, and sample DNA treatments used to induce DNA damage and degradation, and PCR inhibition</a:t>
            </a:r>
            <a:r>
              <a:rPr lang="en-US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Log</a:t>
            </a:r>
            <a:r>
              <a:rPr lang="en-US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0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(LR) values obtained in STRmix (shown in magenta) and EFM (shown in blue) when two, three, and four person mixtures were compared to known contributors (H1-true or sensitivity test). Log</a:t>
            </a:r>
            <a:r>
              <a:rPr lang="en-US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0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(LR) values obtained in STRmix (shown in cyan) and EFM (shown in green) when two, three, and four person mixtures were compared to known non-donors (H2- true or specificity test). The central horizontal line at log</a:t>
            </a:r>
            <a:r>
              <a:rPr lang="en-US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0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(LR) = 0 represents neutrality. LR results of 0 are plotted at −125 on the log</a:t>
            </a:r>
            <a:r>
              <a:rPr lang="en-US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0 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scale.</a:t>
            </a:r>
          </a:p>
          <a:p>
            <a:pPr algn="just"/>
            <a:endParaRPr 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just"/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** Two H1-true test interpretations of 2P mixtures for which STRmix assigned profile LRs of 0 (plotted in magenta at DNase I and UV treatments in the NOC = 2 Person distribution plot) in magenta at −125 on the log</a:t>
            </a:r>
            <a:r>
              <a:rPr lang="en-US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0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 scale and discussed in detail in Section 3.6). </a:t>
            </a:r>
          </a:p>
          <a:p>
            <a:pPr algn="just"/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 </a:t>
            </a:r>
          </a:p>
        </p:txBody>
      </p:sp>
    </p:spTree>
    <p:extLst>
      <p:ext uri="{BB962C8B-B14F-4D97-AF65-F5344CB8AC3E}">
        <p14:creationId xmlns:p14="http://schemas.microsoft.com/office/powerpoint/2010/main" val="372467471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14EA637C-D54E-421C-8CC7-EDC9C8DC5ACF}"/>
              </a:ext>
            </a:extLst>
          </p:cNvPr>
          <p:cNvSpPr txBox="1"/>
          <p:nvPr/>
        </p:nvSpPr>
        <p:spPr>
          <a:xfrm>
            <a:off x="0" y="0"/>
            <a:ext cx="1203820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Log</a:t>
            </a:r>
            <a:r>
              <a:rPr lang="en-US" sz="2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0</a:t>
            </a:r>
            <a:r>
              <a:rPr lang="en-US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LR) Distribution by Software &amp; Treatment for 2 Person Mixtures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E5505D9D-756E-4C81-A020-6F502DB20517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820845" y="400110"/>
            <a:ext cx="6396511" cy="6400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91182126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A366DC29-FF70-479D-BA2D-1F39B9E56541}"/>
              </a:ext>
            </a:extLst>
          </p:cNvPr>
          <p:cNvSpPr txBox="1"/>
          <p:nvPr/>
        </p:nvSpPr>
        <p:spPr>
          <a:xfrm>
            <a:off x="0" y="0"/>
            <a:ext cx="1203820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Log</a:t>
            </a:r>
            <a:r>
              <a:rPr lang="en-US" sz="2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0</a:t>
            </a:r>
            <a:r>
              <a:rPr lang="en-US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LR) Distribution by Software &amp; Treatment for 3 Person Mixtures</a:t>
            </a:r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6ADBD9E5-E4C5-497D-841B-9CD25686BBE1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817005" y="400110"/>
            <a:ext cx="6404191" cy="6400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823351054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94D3E828-BFB6-44AB-92D4-132AD10F733B}"/>
              </a:ext>
            </a:extLst>
          </p:cNvPr>
          <p:cNvSpPr txBox="1"/>
          <p:nvPr/>
        </p:nvSpPr>
        <p:spPr>
          <a:xfrm>
            <a:off x="0" y="0"/>
            <a:ext cx="1203820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Log</a:t>
            </a:r>
            <a:r>
              <a:rPr lang="en-US" sz="2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0</a:t>
            </a:r>
            <a:r>
              <a:rPr lang="en-US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LR) Distribution by Software &amp; Treatment for 4 Person Mixtures</a:t>
            </a:r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8A711E92-EF00-4544-82DE-7F1BA475A1EF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817005" y="400110"/>
            <a:ext cx="6404191" cy="6400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82327915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/>
</p:properties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AB73957F21AE394984F7C14244486252" ma:contentTypeVersion="2" ma:contentTypeDescription="Create a new document." ma:contentTypeScope="" ma:versionID="9257d4b4774658276c24bca62ab9b61a">
  <xsd:schema xmlns:xsd="http://www.w3.org/2001/XMLSchema" xmlns:xs="http://www.w3.org/2001/XMLSchema" xmlns:p="http://schemas.microsoft.com/office/2006/metadata/properties" xmlns:ns3="16def918-8aa6-4d32-a507-8df69469fc9f" targetNamespace="http://schemas.microsoft.com/office/2006/metadata/properties" ma:root="true" ma:fieldsID="c0dcced12536570fcf1c8b537cc77aa8" ns3:_="">
    <xsd:import namespace="16def918-8aa6-4d32-a507-8df69469fc9f"/>
    <xsd:element name="properties">
      <xsd:complexType>
        <xsd:sequence>
          <xsd:element name="documentManagement">
            <xsd:complexType>
              <xsd:all>
                <xsd:element ref="ns3:MediaServiceMetadata" minOccurs="0"/>
                <xsd:element ref="ns3:MediaServiceFastMetadata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16def918-8aa6-4d32-a507-8df69469fc9f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Props1.xml><?xml version="1.0" encoding="utf-8"?>
<ds:datastoreItem xmlns:ds="http://schemas.openxmlformats.org/officeDocument/2006/customXml" ds:itemID="{7A3058CB-D426-4C55-884F-5BC024168D36}">
  <ds:schemaRefs>
    <ds:schemaRef ds:uri="16def918-8aa6-4d32-a507-8df69469fc9f"/>
    <ds:schemaRef ds:uri="http://purl.org/dc/elements/1.1/"/>
    <ds:schemaRef ds:uri="http://schemas.microsoft.com/office/2006/metadata/properties"/>
    <ds:schemaRef ds:uri="http://purl.org/dc/terms/"/>
    <ds:schemaRef ds:uri="http://schemas.openxmlformats.org/package/2006/metadata/core-properties"/>
    <ds:schemaRef ds:uri="http://schemas.microsoft.com/office/2006/documentManagement/types"/>
    <ds:schemaRef ds:uri="http://schemas.microsoft.com/office/infopath/2007/PartnerControls"/>
    <ds:schemaRef ds:uri="http://www.w3.org/XML/1998/namespace"/>
    <ds:schemaRef ds:uri="http://purl.org/dc/dcmitype/"/>
  </ds:schemaRefs>
</ds:datastoreItem>
</file>

<file path=customXml/itemProps2.xml><?xml version="1.0" encoding="utf-8"?>
<ds:datastoreItem xmlns:ds="http://schemas.openxmlformats.org/officeDocument/2006/customXml" ds:itemID="{5F16B353-2DC5-4BB0-A6B3-D39996901A59}">
  <ds:schemaRefs>
    <ds:schemaRef ds:uri="http://schemas.microsoft.com/sharepoint/v3/contenttype/forms"/>
  </ds:schemaRefs>
</ds:datastoreItem>
</file>

<file path=customXml/itemProps3.xml><?xml version="1.0" encoding="utf-8"?>
<ds:datastoreItem xmlns:ds="http://schemas.openxmlformats.org/officeDocument/2006/customXml" ds:itemID="{4C7A3457-0DE0-4961-9965-5A36BBE12E44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16def918-8aa6-4d32-a507-8df69469fc9f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otalTime>69</TotalTime>
  <Words>267</Words>
  <Application>Microsoft Office PowerPoint</Application>
  <PresentationFormat>Widescreen</PresentationFormat>
  <Paragraphs>7</Paragraphs>
  <Slides>4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9" baseType="lpstr"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Riman, Sarah (Assoc)</dc:creator>
  <cp:lastModifiedBy>Riman, Sarah (Assoc)</cp:lastModifiedBy>
  <cp:revision>48</cp:revision>
  <dcterms:created xsi:type="dcterms:W3CDTF">2020-09-07T01:57:31Z</dcterms:created>
  <dcterms:modified xsi:type="dcterms:W3CDTF">2021-03-28T19:16:58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AB73957F21AE394984F7C14244486252</vt:lpwstr>
  </property>
</Properties>
</file>